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0" r:id="rId2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7E7E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550" autoAdjust="0"/>
    <p:restoredTop sz="96041" autoAdjust="0"/>
  </p:normalViewPr>
  <p:slideViewPr>
    <p:cSldViewPr snapToGrid="0">
      <p:cViewPr varScale="1">
        <p:scale>
          <a:sx n="48" d="100"/>
          <a:sy n="48" d="100"/>
        </p:scale>
        <p:origin x="2430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88" d="100"/>
          <a:sy n="88" d="100"/>
        </p:scale>
        <p:origin x="2752" y="200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7075B68-06ED-4B99-9167-52503C359C84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AD5C681-C0CF-482C-BA96-F1B2179907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00850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14632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55025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93932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45176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2342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04245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95422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4402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641469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60363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84083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88682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/>
          </p:nvPr>
        </p:nvGraphicFramePr>
        <p:xfrm>
          <a:off x="1628423" y="3156696"/>
          <a:ext cx="3543323" cy="4063372"/>
        </p:xfrm>
        <a:graphic>
          <a:graphicData uri="http://schemas.openxmlformats.org/drawingml/2006/table">
            <a:tbl>
              <a:tblPr firstRow="1" bandRow="1">
                <a:tableStyleId>{EB344D84-9AFB-497E-A393-DC336BA19D2E}</a:tableStyleId>
              </a:tblPr>
              <a:tblGrid>
                <a:gridCol w="533753"/>
                <a:gridCol w="609600"/>
                <a:gridCol w="762000"/>
                <a:gridCol w="1637970"/>
              </a:tblGrid>
              <a:tr h="462916">
                <a:tc>
                  <a:txBody>
                    <a:bodyPr/>
                    <a:lstStyle/>
                    <a:p>
                      <a:pPr algn="ctr"/>
                      <a:r>
                        <a:rPr lang="en-US" sz="900" i="1" dirty="0" smtClean="0"/>
                        <a:t>Case No.</a:t>
                      </a:r>
                      <a:endParaRPr lang="en-US" sz="900" i="1" dirty="0"/>
                    </a:p>
                  </a:txBody>
                  <a:tcPr marL="51435" marR="51435" marT="25718" marB="25718" anchor="ctr">
                    <a:solidFill>
                      <a:schemeClr val="accent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i="1" dirty="0" smtClean="0"/>
                        <a:t>%</a:t>
                      </a:r>
                      <a:r>
                        <a:rPr lang="en-US" sz="900" i="1" baseline="0" dirty="0" smtClean="0"/>
                        <a:t> Tumor Area</a:t>
                      </a:r>
                      <a:endParaRPr lang="en-US" sz="900" i="1" dirty="0"/>
                    </a:p>
                  </a:txBody>
                  <a:tcPr marL="51435" marR="51435" marT="25718" marB="25718" anchor="ctr">
                    <a:solidFill>
                      <a:schemeClr val="accent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i="1" dirty="0" smtClean="0"/>
                        <a:t>Histology</a:t>
                      </a:r>
                      <a:endParaRPr lang="en-US" sz="900" i="1" dirty="0"/>
                    </a:p>
                  </a:txBody>
                  <a:tcPr marL="51435" marR="51435" marT="25718" marB="25718" anchor="ctr">
                    <a:solidFill>
                      <a:schemeClr val="accent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i="1" dirty="0" smtClean="0"/>
                        <a:t>Size of Lesions (mm)</a:t>
                      </a:r>
                      <a:endParaRPr lang="en-US" sz="900" i="1" dirty="0"/>
                    </a:p>
                  </a:txBody>
                  <a:tcPr marL="51435" marR="51435" marT="25718" marB="25718" anchor="ctr">
                    <a:solidFill>
                      <a:schemeClr val="accent1">
                        <a:lumMod val="50000"/>
                      </a:schemeClr>
                    </a:solidFill>
                  </a:tcPr>
                </a:tc>
              </a:tr>
              <a:tr h="600076"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/>
                        <a:t>H149</a:t>
                      </a:r>
                      <a:endParaRPr lang="en-US" sz="90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/>
                        <a:t>50-100</a:t>
                      </a:r>
                      <a:endParaRPr lang="en-US" sz="90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/>
                        <a:t>Sigmoid,</a:t>
                      </a:r>
                      <a:r>
                        <a:rPr lang="en-US" sz="900" baseline="0" dirty="0" smtClean="0"/>
                        <a:t> low-grade, TVA</a:t>
                      </a:r>
                      <a:endParaRPr lang="en-US" sz="90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/>
                        <a:t>Polyp 1 (FFPE No. 5, 6, 7, 8)</a:t>
                      </a:r>
                      <a:r>
                        <a:rPr lang="en-US" sz="900" baseline="0" dirty="0" smtClean="0"/>
                        <a:t> </a:t>
                      </a:r>
                      <a:r>
                        <a:rPr lang="mr-IN" sz="900" baseline="0" dirty="0" smtClean="0"/>
                        <a:t>–</a:t>
                      </a:r>
                      <a:r>
                        <a:rPr lang="en-US" sz="900" baseline="0" dirty="0" smtClean="0"/>
                        <a:t> 25 x 20 x 25</a:t>
                      </a:r>
                    </a:p>
                    <a:p>
                      <a:pPr algn="ctr"/>
                      <a:r>
                        <a:rPr lang="en-US" sz="900" baseline="0" dirty="0" smtClean="0"/>
                        <a:t>Polyp 2 (FFPE No. 11, 12) </a:t>
                      </a:r>
                      <a:r>
                        <a:rPr lang="mr-IN" sz="900" baseline="0" dirty="0" smtClean="0"/>
                        <a:t>–</a:t>
                      </a:r>
                      <a:r>
                        <a:rPr lang="en-US" sz="900" baseline="0" dirty="0" smtClean="0"/>
                        <a:t> 15 x 15 x 15</a:t>
                      </a:r>
                      <a:endParaRPr lang="en-US" sz="900" dirty="0"/>
                    </a:p>
                  </a:txBody>
                  <a:tcPr marL="51435" marR="51435" marT="25718" marB="25718" anchor="ctr"/>
                </a:tc>
              </a:tr>
              <a:tr h="462916"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/>
                        <a:t>H154</a:t>
                      </a:r>
                      <a:endParaRPr lang="en-US" sz="90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/>
                        <a:t>80</a:t>
                      </a:r>
                      <a:endParaRPr lang="en-US" sz="90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/>
                        <a:t>Descending colon, low-grade,</a:t>
                      </a:r>
                      <a:r>
                        <a:rPr lang="en-US" sz="900" baseline="0" dirty="0" smtClean="0"/>
                        <a:t> TVA</a:t>
                      </a:r>
                      <a:endParaRPr lang="en-US" sz="90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/>
                        <a:t>17</a:t>
                      </a:r>
                      <a:r>
                        <a:rPr lang="en-US" sz="900" baseline="0" dirty="0" smtClean="0"/>
                        <a:t> x 15 x 14</a:t>
                      </a:r>
                      <a:endParaRPr lang="en-US" sz="900" dirty="0"/>
                    </a:p>
                  </a:txBody>
                  <a:tcPr marL="51435" marR="51435" marT="25718" marB="25718" anchor="ctr"/>
                </a:tc>
              </a:tr>
              <a:tr h="737236"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/>
                        <a:t>H263</a:t>
                      </a:r>
                      <a:endParaRPr lang="en-US" sz="90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/>
                        <a:t>100</a:t>
                      </a:r>
                      <a:endParaRPr lang="en-US" sz="90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/>
                        <a:t>Rectum,</a:t>
                      </a:r>
                      <a:r>
                        <a:rPr lang="en-US" sz="900" baseline="0" dirty="0" smtClean="0"/>
                        <a:t> low &amp; high-grade TVA with focal AC</a:t>
                      </a:r>
                      <a:endParaRPr lang="en-US" sz="90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/>
                        <a:t>3</a:t>
                      </a:r>
                      <a:r>
                        <a:rPr lang="en-US" sz="900" baseline="0" dirty="0" smtClean="0"/>
                        <a:t> large polypoid pieces:</a:t>
                      </a:r>
                    </a:p>
                    <a:p>
                      <a:pPr algn="ctr"/>
                      <a:r>
                        <a:rPr lang="en-US" sz="900" baseline="0" dirty="0" smtClean="0"/>
                        <a:t>Piece 1 (FFPE No. 3, 4, 6) </a:t>
                      </a:r>
                      <a:r>
                        <a:rPr lang="mr-IN" sz="900" baseline="0" dirty="0" smtClean="0"/>
                        <a:t>–</a:t>
                      </a:r>
                      <a:r>
                        <a:rPr lang="en-US" sz="900" baseline="0" dirty="0" smtClean="0"/>
                        <a:t> 30 x 25 x 22</a:t>
                      </a:r>
                    </a:p>
                    <a:p>
                      <a:pPr algn="ctr"/>
                      <a:r>
                        <a:rPr lang="en-US" sz="900" baseline="0" dirty="0" smtClean="0"/>
                        <a:t>Piece 2 (FFPE No. 8) </a:t>
                      </a:r>
                      <a:r>
                        <a:rPr lang="mr-IN" sz="900" baseline="0" dirty="0" smtClean="0"/>
                        <a:t>–</a:t>
                      </a:r>
                      <a:r>
                        <a:rPr lang="en-US" sz="900" baseline="0" dirty="0" smtClean="0"/>
                        <a:t> 17 x 30 x 10</a:t>
                      </a:r>
                    </a:p>
                    <a:p>
                      <a:pPr algn="ctr"/>
                      <a:r>
                        <a:rPr lang="en-US" sz="900" baseline="0" dirty="0" smtClean="0"/>
                        <a:t>Piece 3 (FFPE No. 10-1) - 30 x 15 x 10</a:t>
                      </a:r>
                      <a:endParaRPr lang="en-US" sz="900" dirty="0"/>
                    </a:p>
                  </a:txBody>
                  <a:tcPr marL="51435" marR="51435" marT="25718" marB="25718" anchor="ctr"/>
                </a:tc>
              </a:tr>
              <a:tr h="462916"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/>
                        <a:t>H264</a:t>
                      </a:r>
                      <a:endParaRPr lang="en-US" sz="90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/>
                        <a:t>80-100</a:t>
                      </a:r>
                      <a:endParaRPr lang="en-US" sz="90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/>
                        <a:t>Sigmoid,</a:t>
                      </a:r>
                      <a:r>
                        <a:rPr lang="en-US" sz="900" baseline="0" dirty="0" smtClean="0"/>
                        <a:t> low &amp; high-grade TVA</a:t>
                      </a:r>
                      <a:endParaRPr lang="en-US" sz="90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/>
                        <a:t>5 x 5 x 3 </a:t>
                      </a:r>
                      <a:r>
                        <a:rPr lang="mr-IN" sz="900" dirty="0" smtClean="0"/>
                        <a:t>–</a:t>
                      </a:r>
                      <a:r>
                        <a:rPr lang="en-US" sz="900" dirty="0" smtClean="0"/>
                        <a:t> 10 x 10 x 16</a:t>
                      </a:r>
                      <a:endParaRPr lang="en-US" sz="900" dirty="0"/>
                    </a:p>
                  </a:txBody>
                  <a:tcPr marL="51435" marR="51435" marT="25718" marB="25718" anchor="ctr"/>
                </a:tc>
              </a:tr>
              <a:tr h="462916"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/>
                        <a:t>H265</a:t>
                      </a:r>
                      <a:endParaRPr lang="en-US" sz="90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/>
                        <a:t>100</a:t>
                      </a:r>
                      <a:endParaRPr lang="en-US" sz="90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/>
                        <a:t>Distal</a:t>
                      </a:r>
                      <a:r>
                        <a:rPr lang="en-US" sz="900" baseline="0" dirty="0" smtClean="0"/>
                        <a:t> sigmoid, low &amp; high-grade VA</a:t>
                      </a:r>
                      <a:endParaRPr lang="en-US" sz="90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/>
                        <a:t>20 x 35 x 55 </a:t>
                      </a:r>
                      <a:r>
                        <a:rPr lang="en-US" sz="900" baseline="0" dirty="0" smtClean="0"/>
                        <a:t> </a:t>
                      </a:r>
                      <a:r>
                        <a:rPr lang="en-US" sz="900" dirty="0" smtClean="0"/>
                        <a:t>(multiple fragments from one large polypoid)</a:t>
                      </a:r>
                      <a:endParaRPr lang="en-US" sz="900" dirty="0"/>
                    </a:p>
                  </a:txBody>
                  <a:tcPr marL="51435" marR="51435" marT="25718" marB="25718" anchor="ctr"/>
                </a:tc>
              </a:tr>
              <a:tr h="325755"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/>
                        <a:t>H266</a:t>
                      </a:r>
                      <a:endParaRPr lang="en-US" sz="90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/>
                        <a:t>100</a:t>
                      </a:r>
                      <a:endParaRPr lang="en-US" sz="90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/>
                        <a:t>Sigmoid, low-grade</a:t>
                      </a:r>
                      <a:r>
                        <a:rPr lang="en-US" sz="900" baseline="0" dirty="0" smtClean="0"/>
                        <a:t> VA</a:t>
                      </a:r>
                      <a:endParaRPr lang="en-US" sz="90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/>
                        <a:t>60</a:t>
                      </a:r>
                      <a:r>
                        <a:rPr lang="en-US" sz="900" baseline="0" dirty="0" smtClean="0"/>
                        <a:t> (no further measurements reported, multiple polypoid tissues)</a:t>
                      </a:r>
                      <a:endParaRPr lang="en-US" sz="900" dirty="0"/>
                    </a:p>
                  </a:txBody>
                  <a:tcPr marL="51435" marR="51435" marT="25718" marB="25718" anchor="ctr"/>
                </a:tc>
              </a:tr>
            </a:tbl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1559840" y="2682867"/>
            <a:ext cx="36119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Supplemental Table 1: </a:t>
            </a:r>
            <a:r>
              <a:rPr lang="en-GB" sz="1200" dirty="0"/>
              <a:t>Histology details of the sequenced patient </a:t>
            </a:r>
            <a:r>
              <a:rPr lang="en-GB" sz="1200" dirty="0" smtClean="0"/>
              <a:t>cases.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25377318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19</TotalTime>
  <Words>201</Words>
  <Application>Microsoft Office PowerPoint</Application>
  <PresentationFormat>Widescreen</PresentationFormat>
  <Paragraphs>3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Mangal</vt:lpstr>
      <vt:lpstr>Office Theme</vt:lpstr>
      <vt:lpstr>PowerPoint Presentation</vt:lpstr>
    </vt:vector>
  </TitlesOfParts>
  <Company>University of Leicester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e Myint, Ni Ni</dc:creator>
  <cp:lastModifiedBy>Rufini, Alessandro (Dr.)</cp:lastModifiedBy>
  <cp:revision>142</cp:revision>
  <dcterms:created xsi:type="dcterms:W3CDTF">2017-04-06T10:16:01Z</dcterms:created>
  <dcterms:modified xsi:type="dcterms:W3CDTF">2018-04-18T11:04:18Z</dcterms:modified>
</cp:coreProperties>
</file>